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5582667-6102-27E7-ED8E-01A166EB4B6B}" name="Guest User" initials="GU" userId="Guest User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16" d="100"/>
          <a:sy n="116" d="100"/>
        </p:scale>
        <p:origin x="8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ika Weber" userId="b5cfb3ad-a2c8-402c-b5f7-d7062b09d32d" providerId="ADAL" clId="{F033FA75-CA79-5135-8035-E1BF39498D61}"/>
    <pc:docChg chg="custSel addSld delSld modSld">
      <pc:chgData name="Annika Weber" userId="b5cfb3ad-a2c8-402c-b5f7-d7062b09d32d" providerId="ADAL" clId="{F033FA75-CA79-5135-8035-E1BF39498D61}" dt="2025-11-23T16:26:40.827" v="187" actId="14100"/>
      <pc:docMkLst>
        <pc:docMk/>
      </pc:docMkLst>
      <pc:sldChg chg="addSp delSp modSp new mod">
        <pc:chgData name="Annika Weber" userId="b5cfb3ad-a2c8-402c-b5f7-d7062b09d32d" providerId="ADAL" clId="{F033FA75-CA79-5135-8035-E1BF39498D61}" dt="2025-11-23T16:26:40.827" v="187" actId="14100"/>
        <pc:sldMkLst>
          <pc:docMk/>
          <pc:sldMk cId="1934795677" sldId="257"/>
        </pc:sldMkLst>
        <pc:spChg chg="add mod">
          <ac:chgData name="Annika Weber" userId="b5cfb3ad-a2c8-402c-b5f7-d7062b09d32d" providerId="ADAL" clId="{F033FA75-CA79-5135-8035-E1BF39498D61}" dt="2025-11-23T16:26:40.827" v="187" actId="14100"/>
          <ac:spMkLst>
            <pc:docMk/>
            <pc:sldMk cId="1934795677" sldId="257"/>
            <ac:spMk id="5" creationId="{7A2FC9C3-8BE7-1D67-25C0-B0FA700EDCC8}"/>
          </ac:spMkLst>
        </pc:spChg>
        <pc:picChg chg="add mod modCrop">
          <ac:chgData name="Annika Weber" userId="b5cfb3ad-a2c8-402c-b5f7-d7062b09d32d" providerId="ADAL" clId="{F033FA75-CA79-5135-8035-E1BF39498D61}" dt="2025-11-23T16:23:52.979" v="125" actId="732"/>
          <ac:picMkLst>
            <pc:docMk/>
            <pc:sldMk cId="1934795677" sldId="257"/>
            <ac:picMk id="4" creationId="{7E1FEE3C-7EDD-6F5D-6F46-A4F92EB019AA}"/>
          </ac:picMkLst>
        </pc:picChg>
      </pc:sldChg>
    </pc:docChg>
  </pc:docChgLst>
  <pc:docChgLst>
    <pc:chgData name="cam.bovaird@colostate.edu" userId="S::urn:spo:guest#cam.bovaird@colostate.edu::" providerId="AD" clId="Web-{2E50CAD6-F569-8841-432A-8F4641CC4BBB}"/>
    <pc:docChg chg="modSld">
      <pc:chgData name="cam.bovaird@colostate.edu" userId="S::urn:spo:guest#cam.bovaird@colostate.edu::" providerId="AD" clId="Web-{2E50CAD6-F569-8841-432A-8F4641CC4BBB}" dt="2025-11-19T00:09:32.554" v="71" actId="1076"/>
      <pc:docMkLst>
        <pc:docMk/>
      </pc:docMkLst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BB4549-13F4-FDDB-5BDC-FE13805DF3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3505F4-625C-960E-0298-07265CD5DD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932F63-6D8E-F54E-A68A-E1D413445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61FE3-42B1-7746-A3FF-2715DA7D2EA4}" type="datetimeFigureOut">
              <a:rPr lang="en-US" smtClean="0"/>
              <a:t>11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A07649-7532-7EDD-7ED9-BF14346FC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3F5C64-8B71-26AF-7D8B-0609DA9C1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3DB8-4290-7B46-9375-B8603D701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23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6E9EAF-F140-58A2-7DBC-5AA502857F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329C42-3F1E-7324-E332-99DBE610F3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FDF4A2-C4CA-C39C-CCB2-6EB89DA83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61FE3-42B1-7746-A3FF-2715DA7D2EA4}" type="datetimeFigureOut">
              <a:rPr lang="en-US" smtClean="0"/>
              <a:t>11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73C039-0E4D-9E33-AD39-0D14D86069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CE3154-EB36-3EC9-4F86-731B20675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3DB8-4290-7B46-9375-B8603D701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756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3B4C0DE-FA1B-4577-C55B-46C9771A6D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D7017C-CF8F-7D3C-FEA3-FB95B912FD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F4EDDD-BF50-1B1E-7DB8-07C4ACBBE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61FE3-42B1-7746-A3FF-2715DA7D2EA4}" type="datetimeFigureOut">
              <a:rPr lang="en-US" smtClean="0"/>
              <a:t>11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DD3D6D-FC3E-BC9F-6F96-730E14571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42BFA6-AB6A-D700-6C2C-7A0BC414D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3DB8-4290-7B46-9375-B8603D701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9069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17B9A7-7DC1-2252-7055-48AA6F12B4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69EB3F-41D6-AB99-42E3-CFD8AD2035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257B32-7DCA-1B7D-1EB7-380EA58ADB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61FE3-42B1-7746-A3FF-2715DA7D2EA4}" type="datetimeFigureOut">
              <a:rPr lang="en-US" smtClean="0"/>
              <a:t>11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E0EAE6-8639-508D-4579-6B7713ECD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9BF134-8DF7-75DB-C865-08490F4E2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3DB8-4290-7B46-9375-B8603D701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720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2260B5-2693-9E4B-C705-5EB88759AF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76DCF2-6632-40BF-6A73-505571BE19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92CB33-21B8-06FE-30A5-12CF3D6AF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61FE3-42B1-7746-A3FF-2715DA7D2EA4}" type="datetimeFigureOut">
              <a:rPr lang="en-US" smtClean="0"/>
              <a:t>11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81E328-A3C1-CCC4-4209-4FF8F163A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EE38F7-9E13-29BA-11F8-40DB38455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3DB8-4290-7B46-9375-B8603D701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753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72FCCF-411D-47FE-5536-A8B120C212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2D5782-E4ED-5B1A-1F4B-54154DACE6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60566B-18F0-C146-F735-EE2D910290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40E598-BA19-F70B-49A9-34E58F66C6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61FE3-42B1-7746-A3FF-2715DA7D2EA4}" type="datetimeFigureOut">
              <a:rPr lang="en-US" smtClean="0"/>
              <a:t>11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100BB5-1E17-831C-0DA8-D35FA4BB6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F8FDB9-CE8D-A8B0-F6F0-551EC0321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3DB8-4290-7B46-9375-B8603D701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279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29A73A-D4D5-65F8-3FA0-FFA0541128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097E47-2F07-42BD-BFAE-0D716876AD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C6D064-0BAF-764A-81FC-C8902A48F2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24A569-9BD2-76F7-2835-0D056469730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ACA166E-0BDC-E541-8A38-537E90A535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F0B9E5-8395-5A0B-C683-26046C16D9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61FE3-42B1-7746-A3FF-2715DA7D2EA4}" type="datetimeFigureOut">
              <a:rPr lang="en-US" smtClean="0"/>
              <a:t>11/23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6C328ED-0A7E-FE20-7910-EC27EFC3E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C0C9572-0D97-7CF7-262F-A05EA01E9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3DB8-4290-7B46-9375-B8603D701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336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809756-9957-9FC7-CCEA-A60CA0A320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00788E5-17C0-B8BF-68DD-5AF99E3693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61FE3-42B1-7746-A3FF-2715DA7D2EA4}" type="datetimeFigureOut">
              <a:rPr lang="en-US" smtClean="0"/>
              <a:t>11/23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0737DFF-2D52-64B6-B5DE-982DEE5AC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25FB76-C09C-323C-69AE-24944FB894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3DB8-4290-7B46-9375-B8603D701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704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86120C-9314-600C-30CE-6A9390F47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61FE3-42B1-7746-A3FF-2715DA7D2EA4}" type="datetimeFigureOut">
              <a:rPr lang="en-US" smtClean="0"/>
              <a:t>11/23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9B3BB0E-D681-B4E2-6E73-B933CB635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0108B1-069D-6343-4B12-00485D1DC1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3DB8-4290-7B46-9375-B8603D701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013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A108E9-8CD0-4920-E4EC-FC4FA53CD1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DAB6A9-764D-A65A-886A-8F32D81015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663C6A-F619-58D0-4BA7-0C0081554C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799B1E-4679-4531-397F-90F58ECD3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61FE3-42B1-7746-A3FF-2715DA7D2EA4}" type="datetimeFigureOut">
              <a:rPr lang="en-US" smtClean="0"/>
              <a:t>11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7B3B6E-711A-7D9C-2006-C8DB720CAB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E83839-F253-2304-F59B-2DBAABA1D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3DB8-4290-7B46-9375-B8603D701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296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4ECFA6-D6C9-0F4F-7C3B-9EE54625B1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020FCA6-24B5-EC0F-9409-D27C8DFAF7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45008B-9ACE-719A-4257-5B2101939B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D881E6-DF1E-13D8-930C-4295CDFA9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161FE3-42B1-7746-A3FF-2715DA7D2EA4}" type="datetimeFigureOut">
              <a:rPr lang="en-US" smtClean="0"/>
              <a:t>11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5D0F01-7984-F31C-DB82-6A99BA640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1532F0-172D-35DE-1D19-003C3F857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3DB8-4290-7B46-9375-B8603D701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37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60C2D0-BFEA-E976-9BB6-B2F0CE99A9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8B2751-00C3-715F-4707-D9C23AE7CF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8E66C4-1BC7-2029-4294-E6BE2B63B08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161FE3-42B1-7746-A3FF-2715DA7D2EA4}" type="datetimeFigureOut">
              <a:rPr lang="en-US" smtClean="0"/>
              <a:t>11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9C6841-D706-0AF5-F4CF-509DF3FD5C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50FC6C-2BEC-8168-E6B3-AE7779B9C5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053DB8-4290-7B46-9375-B8603D701D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330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E1FEE3C-7EDD-6F5D-6F46-A4F92EB019A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21512"/>
          <a:stretch>
            <a:fillRect/>
          </a:stretch>
        </p:blipFill>
        <p:spPr>
          <a:xfrm>
            <a:off x="1515737" y="332129"/>
            <a:ext cx="8862152" cy="453732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A2FC9C3-8BE7-1D67-25C0-B0FA700EDCC8}"/>
              </a:ext>
            </a:extLst>
          </p:cNvPr>
          <p:cNvSpPr txBox="1"/>
          <p:nvPr/>
        </p:nvSpPr>
        <p:spPr>
          <a:xfrm>
            <a:off x="1664924" y="5469294"/>
            <a:ext cx="8580763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Supplemental Figure 1. Methods workflow for experimental RUTF nutrient analysis. </a:t>
            </a:r>
            <a:r>
              <a:rPr lang="en-US" sz="1200" baseline="30000" dirty="0">
                <a:latin typeface="Times New Roman"/>
                <a:cs typeface="Times New Roman"/>
              </a:rPr>
              <a:t>*</a:t>
            </a:r>
            <a:r>
              <a:rPr lang="en-US" sz="1200" dirty="0">
                <a:latin typeface="Times New Roman"/>
                <a:ea typeface="+mn-lt"/>
                <a:cs typeface="+mn-lt"/>
              </a:rPr>
              <a:t>Conducted separately for 0%, 5%, 7.5%, and 10% rice bran-RUTFs samples. The figure was created with </a:t>
            </a:r>
            <a:r>
              <a:rPr lang="en-US" sz="1200" dirty="0" err="1">
                <a:latin typeface="Times New Roman"/>
                <a:ea typeface="+mn-lt"/>
                <a:cs typeface="+mn-lt"/>
              </a:rPr>
              <a:t>BioRender.com</a:t>
            </a:r>
            <a:r>
              <a:rPr lang="en-US" sz="1200" dirty="0">
                <a:latin typeface="Times New Roman"/>
                <a:ea typeface="+mn-lt"/>
                <a:cs typeface="+mn-lt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934795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8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nika Weber</dc:creator>
  <cp:lastModifiedBy>Annika Weber</cp:lastModifiedBy>
  <cp:revision>1</cp:revision>
  <dcterms:created xsi:type="dcterms:W3CDTF">2025-10-30T19:49:43Z</dcterms:created>
  <dcterms:modified xsi:type="dcterms:W3CDTF">2025-11-23T16:26:47Z</dcterms:modified>
</cp:coreProperties>
</file>